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notesMasterIdLst>
    <p:notesMasterId r:id="rId3"/>
  </p:notesMasterIdLst>
  <p:sldIdLst>
    <p:sldId id="284" r:id="rId2"/>
  </p:sldIdLst>
  <p:sldSz cx="9120188" cy="6840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1027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B3AE4D-D585-474E-ADE9-C8A9A7091F18}" type="datetimeFigureOut">
              <a:rPr lang="zh-CN" altLang="en-US" smtClean="0"/>
              <a:t>2019/11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3188" y="1143000"/>
            <a:ext cx="4111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CF7499-8023-45B5-BDB9-D34A36751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1312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4014" y="1119505"/>
            <a:ext cx="7752160" cy="2381521"/>
          </a:xfrm>
        </p:spPr>
        <p:txBody>
          <a:bodyPr anchor="b"/>
          <a:lstStyle>
            <a:lvl1pPr algn="ctr">
              <a:defRPr sz="598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0024" y="3592866"/>
            <a:ext cx="6840141" cy="1651546"/>
          </a:xfrm>
        </p:spPr>
        <p:txBody>
          <a:bodyPr/>
          <a:lstStyle>
            <a:lvl1pPr marL="0" indent="0" algn="ctr">
              <a:buNone/>
              <a:defRPr sz="2394"/>
            </a:lvl1pPr>
            <a:lvl2pPr marL="456011" indent="0" algn="ctr">
              <a:buNone/>
              <a:defRPr sz="1995"/>
            </a:lvl2pPr>
            <a:lvl3pPr marL="912023" indent="0" algn="ctr">
              <a:buNone/>
              <a:defRPr sz="1795"/>
            </a:lvl3pPr>
            <a:lvl4pPr marL="1368034" indent="0" algn="ctr">
              <a:buNone/>
              <a:defRPr sz="1596"/>
            </a:lvl4pPr>
            <a:lvl5pPr marL="1824045" indent="0" algn="ctr">
              <a:buNone/>
              <a:defRPr sz="1596"/>
            </a:lvl5pPr>
            <a:lvl6pPr marL="2280056" indent="0" algn="ctr">
              <a:buNone/>
              <a:defRPr sz="1596"/>
            </a:lvl6pPr>
            <a:lvl7pPr marL="2736068" indent="0" algn="ctr">
              <a:buNone/>
              <a:defRPr sz="1596"/>
            </a:lvl7pPr>
            <a:lvl8pPr marL="3192079" indent="0" algn="ctr">
              <a:buNone/>
              <a:defRPr sz="1596"/>
            </a:lvl8pPr>
            <a:lvl9pPr marL="3648090" indent="0" algn="ctr">
              <a:buNone/>
              <a:defRPr sz="1596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t>11/25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46733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t>11/25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101349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26635" y="364195"/>
            <a:ext cx="1966541" cy="579704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7014" y="364195"/>
            <a:ext cx="5785619" cy="579704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t>11/25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5305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t>11/25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85761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2263" y="1705386"/>
            <a:ext cx="7866162" cy="2845473"/>
          </a:xfrm>
        </p:spPr>
        <p:txBody>
          <a:bodyPr anchor="b"/>
          <a:lstStyle>
            <a:lvl1pPr>
              <a:defRPr sz="598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2263" y="4577779"/>
            <a:ext cx="7866162" cy="1496367"/>
          </a:xfrm>
        </p:spPr>
        <p:txBody>
          <a:bodyPr/>
          <a:lstStyle>
            <a:lvl1pPr marL="0" indent="0">
              <a:buNone/>
              <a:defRPr sz="2394">
                <a:solidFill>
                  <a:schemeClr val="tx1"/>
                </a:solidFill>
              </a:defRPr>
            </a:lvl1pPr>
            <a:lvl2pPr marL="456011" indent="0">
              <a:buNone/>
              <a:defRPr sz="1995">
                <a:solidFill>
                  <a:schemeClr val="tx1">
                    <a:tint val="75000"/>
                  </a:schemeClr>
                </a:solidFill>
              </a:defRPr>
            </a:lvl2pPr>
            <a:lvl3pPr marL="912023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3pPr>
            <a:lvl4pPr marL="1368034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4pPr>
            <a:lvl5pPr marL="1824045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5pPr>
            <a:lvl6pPr marL="2280056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6pPr>
            <a:lvl7pPr marL="2736068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7pPr>
            <a:lvl8pPr marL="3192079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8pPr>
            <a:lvl9pPr marL="3648090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t>11/25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91261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7013" y="1820976"/>
            <a:ext cx="3876080" cy="434025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17095" y="1820976"/>
            <a:ext cx="3876080" cy="434025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t>11/25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77835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201" y="364197"/>
            <a:ext cx="7866162" cy="13221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202" y="1676882"/>
            <a:ext cx="3858266" cy="821814"/>
          </a:xfrm>
        </p:spPr>
        <p:txBody>
          <a:bodyPr anchor="b"/>
          <a:lstStyle>
            <a:lvl1pPr marL="0" indent="0">
              <a:buNone/>
              <a:defRPr sz="2394" b="1"/>
            </a:lvl1pPr>
            <a:lvl2pPr marL="456011" indent="0">
              <a:buNone/>
              <a:defRPr sz="1995" b="1"/>
            </a:lvl2pPr>
            <a:lvl3pPr marL="912023" indent="0">
              <a:buNone/>
              <a:defRPr sz="1795" b="1"/>
            </a:lvl3pPr>
            <a:lvl4pPr marL="1368034" indent="0">
              <a:buNone/>
              <a:defRPr sz="1596" b="1"/>
            </a:lvl4pPr>
            <a:lvl5pPr marL="1824045" indent="0">
              <a:buNone/>
              <a:defRPr sz="1596" b="1"/>
            </a:lvl5pPr>
            <a:lvl6pPr marL="2280056" indent="0">
              <a:buNone/>
              <a:defRPr sz="1596" b="1"/>
            </a:lvl6pPr>
            <a:lvl7pPr marL="2736068" indent="0">
              <a:buNone/>
              <a:defRPr sz="1596" b="1"/>
            </a:lvl7pPr>
            <a:lvl8pPr marL="3192079" indent="0">
              <a:buNone/>
              <a:defRPr sz="1596" b="1"/>
            </a:lvl8pPr>
            <a:lvl9pPr marL="3648090" indent="0">
              <a:buNone/>
              <a:defRPr sz="159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8202" y="2498697"/>
            <a:ext cx="3858266" cy="367520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17096" y="1676882"/>
            <a:ext cx="3877268" cy="821814"/>
          </a:xfrm>
        </p:spPr>
        <p:txBody>
          <a:bodyPr anchor="b"/>
          <a:lstStyle>
            <a:lvl1pPr marL="0" indent="0">
              <a:buNone/>
              <a:defRPr sz="2394" b="1"/>
            </a:lvl1pPr>
            <a:lvl2pPr marL="456011" indent="0">
              <a:buNone/>
              <a:defRPr sz="1995" b="1"/>
            </a:lvl2pPr>
            <a:lvl3pPr marL="912023" indent="0">
              <a:buNone/>
              <a:defRPr sz="1795" b="1"/>
            </a:lvl3pPr>
            <a:lvl4pPr marL="1368034" indent="0">
              <a:buNone/>
              <a:defRPr sz="1596" b="1"/>
            </a:lvl4pPr>
            <a:lvl5pPr marL="1824045" indent="0">
              <a:buNone/>
              <a:defRPr sz="1596" b="1"/>
            </a:lvl5pPr>
            <a:lvl6pPr marL="2280056" indent="0">
              <a:buNone/>
              <a:defRPr sz="1596" b="1"/>
            </a:lvl6pPr>
            <a:lvl7pPr marL="2736068" indent="0">
              <a:buNone/>
              <a:defRPr sz="1596" b="1"/>
            </a:lvl7pPr>
            <a:lvl8pPr marL="3192079" indent="0">
              <a:buNone/>
              <a:defRPr sz="1596" b="1"/>
            </a:lvl8pPr>
            <a:lvl9pPr marL="3648090" indent="0">
              <a:buNone/>
              <a:defRPr sz="159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17096" y="2498697"/>
            <a:ext cx="3877268" cy="367520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t>11/25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38878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t>11/25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760873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t>11/25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28976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201" y="456036"/>
            <a:ext cx="2941498" cy="1596126"/>
          </a:xfrm>
        </p:spPr>
        <p:txBody>
          <a:bodyPr anchor="b"/>
          <a:lstStyle>
            <a:lvl1pPr>
              <a:defRPr sz="319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7268" y="984912"/>
            <a:ext cx="4617095" cy="4861216"/>
          </a:xfrm>
        </p:spPr>
        <p:txBody>
          <a:bodyPr/>
          <a:lstStyle>
            <a:lvl1pPr>
              <a:defRPr sz="3192"/>
            </a:lvl1pPr>
            <a:lvl2pPr>
              <a:defRPr sz="2793"/>
            </a:lvl2pPr>
            <a:lvl3pPr>
              <a:defRPr sz="2394"/>
            </a:lvl3pPr>
            <a:lvl4pPr>
              <a:defRPr sz="1995"/>
            </a:lvl4pPr>
            <a:lvl5pPr>
              <a:defRPr sz="1995"/>
            </a:lvl5pPr>
            <a:lvl6pPr>
              <a:defRPr sz="1995"/>
            </a:lvl6pPr>
            <a:lvl7pPr>
              <a:defRPr sz="1995"/>
            </a:lvl7pPr>
            <a:lvl8pPr>
              <a:defRPr sz="1995"/>
            </a:lvl8pPr>
            <a:lvl9pPr>
              <a:defRPr sz="199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8201" y="2052161"/>
            <a:ext cx="2941498" cy="3801883"/>
          </a:xfrm>
        </p:spPr>
        <p:txBody>
          <a:bodyPr/>
          <a:lstStyle>
            <a:lvl1pPr marL="0" indent="0">
              <a:buNone/>
              <a:defRPr sz="1596"/>
            </a:lvl1pPr>
            <a:lvl2pPr marL="456011" indent="0">
              <a:buNone/>
              <a:defRPr sz="1396"/>
            </a:lvl2pPr>
            <a:lvl3pPr marL="912023" indent="0">
              <a:buNone/>
              <a:defRPr sz="1197"/>
            </a:lvl3pPr>
            <a:lvl4pPr marL="1368034" indent="0">
              <a:buNone/>
              <a:defRPr sz="997"/>
            </a:lvl4pPr>
            <a:lvl5pPr marL="1824045" indent="0">
              <a:buNone/>
              <a:defRPr sz="997"/>
            </a:lvl5pPr>
            <a:lvl6pPr marL="2280056" indent="0">
              <a:buNone/>
              <a:defRPr sz="997"/>
            </a:lvl6pPr>
            <a:lvl7pPr marL="2736068" indent="0">
              <a:buNone/>
              <a:defRPr sz="997"/>
            </a:lvl7pPr>
            <a:lvl8pPr marL="3192079" indent="0">
              <a:buNone/>
              <a:defRPr sz="997"/>
            </a:lvl8pPr>
            <a:lvl9pPr marL="3648090" indent="0">
              <a:buNone/>
              <a:defRPr sz="99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t>11/25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8548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201" y="456036"/>
            <a:ext cx="2941498" cy="1596126"/>
          </a:xfrm>
        </p:spPr>
        <p:txBody>
          <a:bodyPr anchor="b"/>
          <a:lstStyle>
            <a:lvl1pPr>
              <a:defRPr sz="319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77268" y="984912"/>
            <a:ext cx="4617095" cy="4861216"/>
          </a:xfrm>
        </p:spPr>
        <p:txBody>
          <a:bodyPr anchor="t"/>
          <a:lstStyle>
            <a:lvl1pPr marL="0" indent="0">
              <a:buNone/>
              <a:defRPr sz="3192"/>
            </a:lvl1pPr>
            <a:lvl2pPr marL="456011" indent="0">
              <a:buNone/>
              <a:defRPr sz="2793"/>
            </a:lvl2pPr>
            <a:lvl3pPr marL="912023" indent="0">
              <a:buNone/>
              <a:defRPr sz="2394"/>
            </a:lvl3pPr>
            <a:lvl4pPr marL="1368034" indent="0">
              <a:buNone/>
              <a:defRPr sz="1995"/>
            </a:lvl4pPr>
            <a:lvl5pPr marL="1824045" indent="0">
              <a:buNone/>
              <a:defRPr sz="1995"/>
            </a:lvl5pPr>
            <a:lvl6pPr marL="2280056" indent="0">
              <a:buNone/>
              <a:defRPr sz="1995"/>
            </a:lvl6pPr>
            <a:lvl7pPr marL="2736068" indent="0">
              <a:buNone/>
              <a:defRPr sz="1995"/>
            </a:lvl7pPr>
            <a:lvl8pPr marL="3192079" indent="0">
              <a:buNone/>
              <a:defRPr sz="1995"/>
            </a:lvl8pPr>
            <a:lvl9pPr marL="3648090" indent="0">
              <a:buNone/>
              <a:defRPr sz="199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8201" y="2052161"/>
            <a:ext cx="2941498" cy="3801883"/>
          </a:xfrm>
        </p:spPr>
        <p:txBody>
          <a:bodyPr/>
          <a:lstStyle>
            <a:lvl1pPr marL="0" indent="0">
              <a:buNone/>
              <a:defRPr sz="1596"/>
            </a:lvl1pPr>
            <a:lvl2pPr marL="456011" indent="0">
              <a:buNone/>
              <a:defRPr sz="1396"/>
            </a:lvl2pPr>
            <a:lvl3pPr marL="912023" indent="0">
              <a:buNone/>
              <a:defRPr sz="1197"/>
            </a:lvl3pPr>
            <a:lvl4pPr marL="1368034" indent="0">
              <a:buNone/>
              <a:defRPr sz="997"/>
            </a:lvl4pPr>
            <a:lvl5pPr marL="1824045" indent="0">
              <a:buNone/>
              <a:defRPr sz="997"/>
            </a:lvl5pPr>
            <a:lvl6pPr marL="2280056" indent="0">
              <a:buNone/>
              <a:defRPr sz="997"/>
            </a:lvl6pPr>
            <a:lvl7pPr marL="2736068" indent="0">
              <a:buNone/>
              <a:defRPr sz="997"/>
            </a:lvl7pPr>
            <a:lvl8pPr marL="3192079" indent="0">
              <a:buNone/>
              <a:defRPr sz="997"/>
            </a:lvl8pPr>
            <a:lvl9pPr marL="3648090" indent="0">
              <a:buNone/>
              <a:defRPr sz="99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t>11/25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69255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7013" y="364197"/>
            <a:ext cx="7866162" cy="1322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7013" y="1820976"/>
            <a:ext cx="7866162" cy="43402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7013" y="6340167"/>
            <a:ext cx="2052042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t>11/25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1063" y="6340167"/>
            <a:ext cx="3078063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41133" y="6340167"/>
            <a:ext cx="2052042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85782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912023" rtl="0" eaLnBrk="1" latinLnBrk="0" hangingPunct="1">
        <a:lnSpc>
          <a:spcPct val="90000"/>
        </a:lnSpc>
        <a:spcBef>
          <a:spcPct val="0"/>
        </a:spcBef>
        <a:buNone/>
        <a:defRPr sz="438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006" indent="-228006" algn="l" defTabSz="912023" rtl="0" eaLnBrk="1" latinLnBrk="0" hangingPunct="1">
        <a:lnSpc>
          <a:spcPct val="90000"/>
        </a:lnSpc>
        <a:spcBef>
          <a:spcPts val="997"/>
        </a:spcBef>
        <a:buFont typeface="Arial" panose="020B0604020202020204" pitchFamily="34" charset="0"/>
        <a:buChar char="•"/>
        <a:defRPr sz="2793" kern="1200">
          <a:solidFill>
            <a:schemeClr val="tx1"/>
          </a:solidFill>
          <a:latin typeface="+mn-lt"/>
          <a:ea typeface="+mn-ea"/>
          <a:cs typeface="+mn-cs"/>
        </a:defRPr>
      </a:lvl1pPr>
      <a:lvl2pPr marL="684017" indent="-228006" algn="l" defTabSz="912023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2394" kern="1200">
          <a:solidFill>
            <a:schemeClr val="tx1"/>
          </a:solidFill>
          <a:latin typeface="+mn-lt"/>
          <a:ea typeface="+mn-ea"/>
          <a:cs typeface="+mn-cs"/>
        </a:defRPr>
      </a:lvl2pPr>
      <a:lvl3pPr marL="1140028" indent="-228006" algn="l" defTabSz="912023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995" kern="1200">
          <a:solidFill>
            <a:schemeClr val="tx1"/>
          </a:solidFill>
          <a:latin typeface="+mn-lt"/>
          <a:ea typeface="+mn-ea"/>
          <a:cs typeface="+mn-cs"/>
        </a:defRPr>
      </a:lvl3pPr>
      <a:lvl4pPr marL="1596039" indent="-228006" algn="l" defTabSz="912023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4pPr>
      <a:lvl5pPr marL="2052051" indent="-228006" algn="l" defTabSz="912023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5pPr>
      <a:lvl6pPr marL="2508062" indent="-228006" algn="l" defTabSz="912023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6pPr>
      <a:lvl7pPr marL="2964073" indent="-228006" algn="l" defTabSz="912023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7pPr>
      <a:lvl8pPr marL="3420085" indent="-228006" algn="l" defTabSz="912023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8pPr>
      <a:lvl9pPr marL="3876096" indent="-228006" algn="l" defTabSz="912023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2023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1pPr>
      <a:lvl2pPr marL="456011" algn="l" defTabSz="912023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912023" algn="l" defTabSz="912023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3pPr>
      <a:lvl4pPr marL="1368034" algn="l" defTabSz="912023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4pPr>
      <a:lvl5pPr marL="1824045" algn="l" defTabSz="912023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5pPr>
      <a:lvl6pPr marL="2280056" algn="l" defTabSz="912023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6pPr>
      <a:lvl7pPr marL="2736068" algn="l" defTabSz="912023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7pPr>
      <a:lvl8pPr marL="3192079" algn="l" defTabSz="912023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8pPr>
      <a:lvl9pPr marL="3648090" algn="l" defTabSz="912023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767646" y="1407182"/>
            <a:ext cx="4441531" cy="1656083"/>
            <a:chOff x="404664" y="3889548"/>
            <a:chExt cx="4464496" cy="1664645"/>
          </a:xfrm>
        </p:grpSpPr>
        <p:grpSp>
          <p:nvGrpSpPr>
            <p:cNvPr id="33" name="组合 32"/>
            <p:cNvGrpSpPr/>
            <p:nvPr/>
          </p:nvGrpSpPr>
          <p:grpSpPr>
            <a:xfrm>
              <a:off x="960078" y="3899073"/>
              <a:ext cx="3832464" cy="597733"/>
              <a:chOff x="1252720" y="3884687"/>
              <a:chExt cx="3832464" cy="597733"/>
            </a:xfrm>
          </p:grpSpPr>
          <p:cxnSp>
            <p:nvCxnSpPr>
              <p:cNvPr id="23" name="肘形连接符 22"/>
              <p:cNvCxnSpPr/>
              <p:nvPr/>
            </p:nvCxnSpPr>
            <p:spPr>
              <a:xfrm flipV="1">
                <a:off x="1252720" y="4139952"/>
                <a:ext cx="3429000" cy="216024"/>
              </a:xfrm>
              <a:prstGeom prst="bentConnector3">
                <a:avLst>
                  <a:gd name="adj1" fmla="val 85659"/>
                </a:avLst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矩形 24"/>
              <p:cNvSpPr/>
              <p:nvPr/>
            </p:nvSpPr>
            <p:spPr>
              <a:xfrm>
                <a:off x="2813458" y="4221560"/>
                <a:ext cx="36000" cy="252000"/>
              </a:xfrm>
              <a:prstGeom prst="rect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defTabSz="909735"/>
                <a:endParaRPr lang="zh-CN" altLang="en-US" sz="895">
                  <a:solidFill>
                    <a:prstClr val="white"/>
                  </a:solidFill>
                  <a:latin typeface="Calibri"/>
                  <a:ea typeface="宋体" panose="02010600030101010101" pitchFamily="2" charset="-122"/>
                </a:endParaRPr>
              </a:p>
            </p:txBody>
          </p:sp>
          <p:sp>
            <p:nvSpPr>
              <p:cNvPr id="26" name="矩形 25"/>
              <p:cNvSpPr/>
              <p:nvPr/>
            </p:nvSpPr>
            <p:spPr>
              <a:xfrm>
                <a:off x="1532409" y="4230420"/>
                <a:ext cx="36000" cy="252000"/>
              </a:xfrm>
              <a:prstGeom prst="rect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defTabSz="909735"/>
                <a:endParaRPr lang="zh-CN" altLang="en-US" sz="895">
                  <a:solidFill>
                    <a:prstClr val="white"/>
                  </a:solidFill>
                  <a:latin typeface="Calibri"/>
                  <a:ea typeface="宋体" panose="02010600030101010101" pitchFamily="2" charset="-122"/>
                </a:endParaRPr>
              </a:p>
            </p:txBody>
          </p:sp>
          <p:sp>
            <p:nvSpPr>
              <p:cNvPr id="27" name="矩形 26"/>
              <p:cNvSpPr/>
              <p:nvPr/>
            </p:nvSpPr>
            <p:spPr>
              <a:xfrm>
                <a:off x="1273370" y="4227165"/>
                <a:ext cx="36000" cy="252000"/>
              </a:xfrm>
              <a:prstGeom prst="rect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defTabSz="909735"/>
                <a:endParaRPr lang="zh-CN" altLang="en-US" sz="895">
                  <a:solidFill>
                    <a:prstClr val="white"/>
                  </a:solidFill>
                  <a:latin typeface="Calibri"/>
                  <a:ea typeface="宋体" panose="02010600030101010101" pitchFamily="2" charset="-122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4221086" y="3884687"/>
                <a:ext cx="864098" cy="2312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09735"/>
                <a:r>
                  <a:rPr lang="en-US" altLang="zh-CN" sz="895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TG</a:t>
                </a:r>
                <a:endParaRPr lang="zh-CN" altLang="en-US" sz="895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矩形 30"/>
              <p:cNvSpPr/>
              <p:nvPr/>
            </p:nvSpPr>
            <p:spPr>
              <a:xfrm>
                <a:off x="2713112" y="4226818"/>
                <a:ext cx="36000" cy="252000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defTabSz="909735"/>
                <a:endParaRPr lang="zh-CN" altLang="en-US" sz="895">
                  <a:solidFill>
                    <a:prstClr val="white"/>
                  </a:solidFill>
                  <a:latin typeface="Calibri"/>
                  <a:ea typeface="宋体" panose="02010600030101010101" pitchFamily="2" charset="-122"/>
                </a:endParaRPr>
              </a:p>
            </p:txBody>
          </p:sp>
          <p:sp>
            <p:nvSpPr>
              <p:cNvPr id="32" name="矩形 31"/>
              <p:cNvSpPr/>
              <p:nvPr/>
            </p:nvSpPr>
            <p:spPr>
              <a:xfrm>
                <a:off x="2612529" y="4225844"/>
                <a:ext cx="36000" cy="252000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defTabSz="909735"/>
                <a:endParaRPr lang="zh-CN" altLang="en-US" sz="895">
                  <a:solidFill>
                    <a:prstClr val="white"/>
                  </a:solidFill>
                  <a:latin typeface="Calibri"/>
                  <a:ea typeface="宋体" panose="02010600030101010101" pitchFamily="2" charset="-122"/>
                </a:endParaRPr>
              </a:p>
            </p:txBody>
          </p:sp>
        </p:grpSp>
        <p:grpSp>
          <p:nvGrpSpPr>
            <p:cNvPr id="40" name="组合 39"/>
            <p:cNvGrpSpPr/>
            <p:nvPr/>
          </p:nvGrpSpPr>
          <p:grpSpPr>
            <a:xfrm>
              <a:off x="980728" y="5296831"/>
              <a:ext cx="3888432" cy="257362"/>
              <a:chOff x="1268760" y="4516238"/>
              <a:chExt cx="3888432" cy="257362"/>
            </a:xfrm>
          </p:grpSpPr>
          <p:sp>
            <p:nvSpPr>
              <p:cNvPr id="34" name="矩形 33"/>
              <p:cNvSpPr/>
              <p:nvPr/>
            </p:nvSpPr>
            <p:spPr>
              <a:xfrm>
                <a:off x="1268760" y="4519532"/>
                <a:ext cx="36000" cy="252000"/>
              </a:xfrm>
              <a:prstGeom prst="rect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defTabSz="909735"/>
                <a:endParaRPr lang="zh-CN" altLang="en-US" sz="895">
                  <a:solidFill>
                    <a:prstClr val="white"/>
                  </a:solidFill>
                  <a:latin typeface="Calibri"/>
                  <a:ea typeface="宋体" panose="02010600030101010101" pitchFamily="2" charset="-122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331243" y="4540004"/>
                <a:ext cx="3825949" cy="2312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09735"/>
                <a:r>
                  <a:rPr lang="en-US" altLang="zh-CN" sz="895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CGTCA-motif                      TCA-element                    ABRE     </a:t>
                </a:r>
                <a:endParaRPr lang="zh-CN" altLang="en-US" sz="895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矩形 35"/>
              <p:cNvSpPr/>
              <p:nvPr/>
            </p:nvSpPr>
            <p:spPr>
              <a:xfrm>
                <a:off x="3779160" y="4516238"/>
                <a:ext cx="36000" cy="252000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defTabSz="909735"/>
                <a:endParaRPr lang="zh-CN" altLang="en-US" sz="895">
                  <a:solidFill>
                    <a:prstClr val="white"/>
                  </a:solidFill>
                  <a:latin typeface="Calibri"/>
                  <a:ea typeface="宋体" panose="02010600030101010101" pitchFamily="2" charset="-122"/>
                </a:endParaRPr>
              </a:p>
            </p:txBody>
          </p:sp>
          <p:sp>
            <p:nvSpPr>
              <p:cNvPr id="38" name="矩形 37"/>
              <p:cNvSpPr/>
              <p:nvPr/>
            </p:nvSpPr>
            <p:spPr>
              <a:xfrm>
                <a:off x="2564904" y="4521600"/>
                <a:ext cx="36000" cy="252000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defTabSz="909735"/>
                <a:endParaRPr lang="zh-CN" altLang="en-US" sz="895">
                  <a:solidFill>
                    <a:prstClr val="white"/>
                  </a:solidFill>
                  <a:latin typeface="Calibri"/>
                  <a:ea typeface="宋体" panose="02010600030101010101" pitchFamily="2" charset="-122"/>
                </a:endParaRPr>
              </a:p>
            </p:txBody>
          </p:sp>
        </p:grpSp>
        <p:sp>
          <p:nvSpPr>
            <p:cNvPr id="44" name="TextBox 43"/>
            <p:cNvSpPr txBox="1"/>
            <p:nvPr/>
          </p:nvSpPr>
          <p:spPr>
            <a:xfrm>
              <a:off x="3715004" y="4519928"/>
              <a:ext cx="794115" cy="2312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09735"/>
              <a:r>
                <a:rPr lang="en-US" altLang="zh-CN" sz="895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24 bp</a:t>
              </a:r>
              <a:endParaRPr lang="zh-CN" altLang="en-US" sz="895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538816" y="4581409"/>
              <a:ext cx="779784" cy="2312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09735"/>
              <a:r>
                <a:rPr lang="en-US" altLang="zh-CN" sz="895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980 bp</a:t>
              </a:r>
              <a:endParaRPr lang="zh-CN" altLang="en-US" sz="895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420470" y="3889548"/>
              <a:ext cx="794115" cy="2312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09735"/>
              <a:r>
                <a:rPr lang="en-US" altLang="zh-CN" sz="895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1060 bp</a:t>
              </a:r>
              <a:endParaRPr lang="zh-CN" altLang="en-US" sz="895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47" name="直接连接符 46"/>
            <p:cNvCxnSpPr/>
            <p:nvPr/>
          </p:nvCxnSpPr>
          <p:spPr>
            <a:xfrm>
              <a:off x="2154323" y="4100226"/>
              <a:ext cx="148627" cy="139824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1772816" y="3902726"/>
              <a:ext cx="794115" cy="2312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09735"/>
              <a:r>
                <a:rPr lang="en-US" altLang="zh-CN" sz="895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1085 bp</a:t>
              </a:r>
              <a:endParaRPr lang="zh-CN" altLang="en-US" sz="895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49" name="直接连接符 48"/>
            <p:cNvCxnSpPr/>
            <p:nvPr/>
          </p:nvCxnSpPr>
          <p:spPr>
            <a:xfrm rot="5400000">
              <a:off x="2468789" y="4097554"/>
              <a:ext cx="148627" cy="139824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连接符 49"/>
            <p:cNvCxnSpPr/>
            <p:nvPr/>
          </p:nvCxnSpPr>
          <p:spPr>
            <a:xfrm rot="5400000">
              <a:off x="810114" y="4489642"/>
              <a:ext cx="148627" cy="139824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连接符 50"/>
            <p:cNvCxnSpPr/>
            <p:nvPr/>
          </p:nvCxnSpPr>
          <p:spPr>
            <a:xfrm>
              <a:off x="1307582" y="4467500"/>
              <a:ext cx="148627" cy="139824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/>
            <p:cNvSpPr txBox="1"/>
            <p:nvPr/>
          </p:nvSpPr>
          <p:spPr>
            <a:xfrm>
              <a:off x="1260376" y="4540131"/>
              <a:ext cx="794115" cy="2312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09735"/>
              <a:r>
                <a:rPr lang="en-US" altLang="zh-CN" sz="895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1865 bp</a:t>
              </a:r>
              <a:endParaRPr lang="zh-CN" altLang="en-US" sz="895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04664" y="4571641"/>
              <a:ext cx="794115" cy="2312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09735"/>
              <a:r>
                <a:rPr lang="en-US" altLang="zh-CN" sz="895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2009 bp</a:t>
              </a:r>
              <a:endParaRPr lang="zh-CN" altLang="en-US" sz="895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1710702" y="1732687"/>
            <a:ext cx="1630045" cy="2608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09735"/>
            <a:r>
              <a:rPr lang="en-US" altLang="zh-CN" sz="1095" i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WRKY42-B</a:t>
            </a:r>
            <a:r>
              <a:rPr lang="en-US" altLang="zh-CN" sz="1095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romoter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667612" y="738098"/>
            <a:ext cx="2292404" cy="3065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09735"/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le 4: Fig. S4</a:t>
            </a:r>
            <a:endParaRPr lang="zh-CN" altLang="en-US" sz="14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41" name="直接连接符 40"/>
          <p:cNvCxnSpPr/>
          <p:nvPr/>
        </p:nvCxnSpPr>
        <p:spPr>
          <a:xfrm>
            <a:off x="4918794" y="2001165"/>
            <a:ext cx="147862" cy="139105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矩形 41"/>
          <p:cNvSpPr/>
          <p:nvPr/>
        </p:nvSpPr>
        <p:spPr>
          <a:xfrm>
            <a:off x="6154982" y="1742248"/>
            <a:ext cx="35814" cy="250704"/>
          </a:xfrm>
          <a:prstGeom prst="rect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909735"/>
            <a:endParaRPr lang="zh-CN" altLang="en-US" sz="895">
              <a:solidFill>
                <a:prstClr val="white"/>
              </a:solidFill>
              <a:latin typeface="Calibri"/>
              <a:ea typeface="宋体" panose="02010600030101010101" pitchFamily="2" charset="-122"/>
            </a:endParaRPr>
          </a:p>
        </p:txBody>
      </p:sp>
      <p:cxnSp>
        <p:nvCxnSpPr>
          <p:cNvPr id="43" name="直接连接符 42"/>
          <p:cNvCxnSpPr/>
          <p:nvPr/>
        </p:nvCxnSpPr>
        <p:spPr>
          <a:xfrm>
            <a:off x="6206252" y="1993861"/>
            <a:ext cx="147862" cy="139105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矩形 2">
            <a:extLst>
              <a:ext uri="{FF2B5EF4-FFF2-40B4-BE49-F238E27FC236}">
                <a16:creationId xmlns:a16="http://schemas.microsoft.com/office/drawing/2014/main" id="{07670951-CCDD-4BB7-BF6A-DBF93E2DEAF6}"/>
              </a:ext>
            </a:extLst>
          </p:cNvPr>
          <p:cNvSpPr/>
          <p:nvPr/>
        </p:nvSpPr>
        <p:spPr>
          <a:xfrm>
            <a:off x="1667612" y="3633947"/>
            <a:ext cx="582924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05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le 4: Fig. S4 Promoter analysis of </a:t>
            </a:r>
            <a:r>
              <a:rPr lang="en-US" altLang="zh-CN" sz="1050" b="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WRKY42-B</a:t>
            </a:r>
            <a:r>
              <a:rPr lang="en-US" altLang="zh-CN" sz="105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n </a:t>
            </a:r>
            <a:r>
              <a:rPr lang="en-US" altLang="zh-CN" sz="1050" b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antCARE</a:t>
            </a:r>
            <a:r>
              <a:rPr lang="en-US" altLang="zh-CN" sz="105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05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</a:t>
            </a:r>
            <a:r>
              <a:rPr lang="en-US" altLang="zh-CN" sz="105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ocalization of </a:t>
            </a:r>
            <a:r>
              <a:rPr lang="en-US" altLang="zh-CN" sz="105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is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elements in </a:t>
            </a:r>
            <a:r>
              <a:rPr lang="en-US" altLang="zh-CN" sz="105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WRKY42-B 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moter region. CGTCA-motif was involved in </a:t>
            </a:r>
            <a:r>
              <a:rPr lang="en-US" altLang="zh-CN" sz="105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eJA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sponsiveness, TCA-element was involved in SA responsiveness</a:t>
            </a:r>
            <a:r>
              <a:rPr lang="zh-CN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，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ABRE was involved in ABA responsiveness.</a:t>
            </a:r>
            <a:endParaRPr lang="zh-CN" altLang="zh-CN" sz="105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2188437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</TotalTime>
  <Words>76</Words>
  <Application>Microsoft Office PowerPoint</Application>
  <PresentationFormat>自定义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2_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耕</dc:creator>
  <cp:lastModifiedBy>王 耕</cp:lastModifiedBy>
  <cp:revision>16</cp:revision>
  <dcterms:created xsi:type="dcterms:W3CDTF">2019-11-25T09:49:18Z</dcterms:created>
  <dcterms:modified xsi:type="dcterms:W3CDTF">2019-11-25T15:37:39Z</dcterms:modified>
</cp:coreProperties>
</file>